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5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D4932-3B20-458F-8959-0DD2CC429EDB}" type="datetimeFigureOut">
              <a:rPr lang="zh-CN" altLang="en-US" smtClean="0"/>
              <a:t>2023/9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7ADE7-517E-4C06-BE0A-F544E2B8D9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03395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D4932-3B20-458F-8959-0DD2CC429EDB}" type="datetimeFigureOut">
              <a:rPr lang="zh-CN" altLang="en-US" smtClean="0"/>
              <a:t>2023/9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7ADE7-517E-4C06-BE0A-F544E2B8D9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22193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D4932-3B20-458F-8959-0DD2CC429EDB}" type="datetimeFigureOut">
              <a:rPr lang="zh-CN" altLang="en-US" smtClean="0"/>
              <a:t>2023/9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7ADE7-517E-4C06-BE0A-F544E2B8D9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32825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D4932-3B20-458F-8959-0DD2CC429EDB}" type="datetimeFigureOut">
              <a:rPr lang="zh-CN" altLang="en-US" smtClean="0"/>
              <a:t>2023/9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7ADE7-517E-4C06-BE0A-F544E2B8D9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696725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D4932-3B20-458F-8959-0DD2CC429EDB}" type="datetimeFigureOut">
              <a:rPr lang="zh-CN" altLang="en-US" smtClean="0"/>
              <a:t>2023/9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7ADE7-517E-4C06-BE0A-F544E2B8D9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16878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D4932-3B20-458F-8959-0DD2CC429EDB}" type="datetimeFigureOut">
              <a:rPr lang="zh-CN" altLang="en-US" smtClean="0"/>
              <a:t>2023/9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7ADE7-517E-4C06-BE0A-F544E2B8D9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9346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D4932-3B20-458F-8959-0DD2CC429EDB}" type="datetimeFigureOut">
              <a:rPr lang="zh-CN" altLang="en-US" smtClean="0"/>
              <a:t>2023/9/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7ADE7-517E-4C06-BE0A-F544E2B8D9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8541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D4932-3B20-458F-8959-0DD2CC429EDB}" type="datetimeFigureOut">
              <a:rPr lang="zh-CN" altLang="en-US" smtClean="0"/>
              <a:t>2023/9/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7ADE7-517E-4C06-BE0A-F544E2B8D9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75790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D4932-3B20-458F-8959-0DD2CC429EDB}" type="datetimeFigureOut">
              <a:rPr lang="zh-CN" altLang="en-US" smtClean="0"/>
              <a:t>2023/9/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7ADE7-517E-4C06-BE0A-F544E2B8D9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39776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D4932-3B20-458F-8959-0DD2CC429EDB}" type="datetimeFigureOut">
              <a:rPr lang="zh-CN" altLang="en-US" smtClean="0"/>
              <a:t>2023/9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7ADE7-517E-4C06-BE0A-F544E2B8D9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12751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D4932-3B20-458F-8959-0DD2CC429EDB}" type="datetimeFigureOut">
              <a:rPr lang="zh-CN" altLang="en-US" smtClean="0"/>
              <a:t>2023/9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7ADE7-517E-4C06-BE0A-F544E2B8D9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53732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3D4932-3B20-458F-8959-0DD2CC429EDB}" type="datetimeFigureOut">
              <a:rPr lang="zh-CN" altLang="en-US" smtClean="0"/>
              <a:t>2023/9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67ADE7-517E-4C06-BE0A-F544E2B8D9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62137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4655" y="0"/>
            <a:ext cx="7755325" cy="6819138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8134709" y="131749"/>
            <a:ext cx="3798499" cy="32778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0"/>
              </a:spcAft>
            </a:pP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Ultrastructure of two strains of </a:t>
            </a:r>
            <a:r>
              <a:rPr lang="en-US" altLang="zh-CN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altLang="zh-CN" i="1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rokiniana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, GT-1; B, CMBB-146). Cell morphology of </a:t>
            </a:r>
            <a:r>
              <a:rPr lang="en-US" altLang="zh-CN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US" altLang="zh-CN" i="1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lhamensis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nder different nutritional conditions (C, without grazing on prey; D, grazing on digestible prey </a:t>
            </a:r>
            <a:r>
              <a:rPr lang="en-US" altLang="zh-CN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altLang="zh-CN" i="1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rokiniana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T-1, E, grazing on indigestible prey </a:t>
            </a:r>
            <a:r>
              <a:rPr lang="en-US" altLang="zh-CN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altLang="zh-CN" i="1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rokiniana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MBB-146). Scale bars: 1 </a:t>
            </a:r>
            <a:r>
              <a:rPr lang="en-US" altLang="zh-CN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A &amp; B; 5 </a:t>
            </a:r>
            <a:r>
              <a:rPr lang="en-US" altLang="zh-CN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C-E.</a:t>
            </a:r>
            <a:endParaRPr lang="zh-CN" altLang="zh-CN" sz="1400" kern="100" dirty="0"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581975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5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amingyang</dc:creator>
  <cp:lastModifiedBy>mamingyang</cp:lastModifiedBy>
  <cp:revision>1</cp:revision>
  <dcterms:created xsi:type="dcterms:W3CDTF">2023-08-31T18:10:02Z</dcterms:created>
  <dcterms:modified xsi:type="dcterms:W3CDTF">2023-08-31T18:10:24Z</dcterms:modified>
</cp:coreProperties>
</file>